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71600" y="1142640"/>
            <a:ext cx="23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43A6B5-4BF8-45C1-AA74-2380BAE8BA7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5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41FAA3-76E8-4298-B793-035DD66AFA8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BFF31D-EC39-4DCC-BB8C-89AD7CA1B7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310280-62C0-4967-B21C-F68E46A540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F82D1-C590-4C0B-B948-AFE748ADB5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866AD7-592D-49CA-887F-CA249EAEAF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53CCC4-ED2D-4136-8D47-7A3C3C9DAB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4C2E8-EED9-47D3-91BD-BA9EFDF230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36AEB-2021-4F80-907A-0E48283F9E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01A33F-D7F3-456D-B601-9B8EBD4B04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597A2-3316-4B37-A4EB-B6D44C2682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E6474-4EB1-4C9E-A313-1CEB837443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1A322-A3EB-44CD-9227-08D7F746AF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48789-4271-4D2B-846E-CEF7EED53E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31AEA0-A8B4-40DB-840E-B09AE143437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"/>
          <p:cNvSpPr/>
          <p:nvPr/>
        </p:nvSpPr>
        <p:spPr>
          <a:xfrm>
            <a:off x="923760" y="6802560"/>
            <a:ext cx="5175360" cy="139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Z-ratio analysis of the microarray datase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Normalized Z-ratio of array intensity data shows a normal distribution of all genes expressed in the STm SL1344-treated leaves as compared to the mock control. The 2% extremes of the bell-shape curve reveal the genes with significant differential expression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Linear regression between relative gene expression calculated with two methods, Z-ratio and Log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old change, shows high positive correlation (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= 0.9676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Chart 16" descr=""/>
          <p:cNvPicPr/>
          <p:nvPr/>
        </p:nvPicPr>
        <p:blipFill>
          <a:blip r:embed="rId1"/>
          <a:stretch/>
        </p:blipFill>
        <p:spPr>
          <a:xfrm>
            <a:off x="984240" y="806400"/>
            <a:ext cx="4749840" cy="2959200"/>
          </a:xfrm>
          <a:prstGeom prst="rect">
            <a:avLst/>
          </a:prstGeom>
          <a:ln w="0">
            <a:noFill/>
          </a:ln>
        </p:spPr>
      </p:pic>
      <p:pic>
        <p:nvPicPr>
          <p:cNvPr id="50" name="Chart 18" descr=""/>
          <p:cNvPicPr/>
          <p:nvPr/>
        </p:nvPicPr>
        <p:blipFill>
          <a:blip r:embed="rId2"/>
          <a:stretch/>
        </p:blipFill>
        <p:spPr>
          <a:xfrm>
            <a:off x="615960" y="3664080"/>
            <a:ext cx="5638680" cy="3098520"/>
          </a:xfrm>
          <a:prstGeom prst="rect">
            <a:avLst/>
          </a:prstGeom>
          <a:ln w="0">
            <a:noFill/>
          </a:ln>
        </p:spPr>
      </p:pic>
      <p:grpSp>
        <p:nvGrpSpPr>
          <p:cNvPr id="51" name="Group 23"/>
          <p:cNvGrpSpPr/>
          <p:nvPr/>
        </p:nvGrpSpPr>
        <p:grpSpPr>
          <a:xfrm>
            <a:off x="1368360" y="3889440"/>
            <a:ext cx="2295720" cy="666360"/>
            <a:chOff x="1368360" y="3889440"/>
            <a:chExt cx="2295720" cy="666360"/>
          </a:xfrm>
        </p:grpSpPr>
        <p:sp>
          <p:nvSpPr>
            <p:cNvPr id="52" name="TextBox 2"/>
            <p:cNvSpPr/>
            <p:nvPr/>
          </p:nvSpPr>
          <p:spPr>
            <a:xfrm>
              <a:off x="1469160" y="3889440"/>
              <a:ext cx="2194920" cy="666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ll gene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ifferentially expressed (Log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gnificance cutoff (Z-score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Oval 7"/>
            <p:cNvSpPr/>
            <p:nvPr/>
          </p:nvSpPr>
          <p:spPr>
            <a:xfrm>
              <a:off x="1398240" y="4167360"/>
              <a:ext cx="72720" cy="54000"/>
            </a:xfrm>
            <a:prstGeom prst="ellipse">
              <a:avLst/>
            </a:prstGeom>
            <a:solidFill>
              <a:srgbClr val="ff0000"/>
            </a:solidFill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Oval 20"/>
            <p:cNvSpPr/>
            <p:nvPr/>
          </p:nvSpPr>
          <p:spPr>
            <a:xfrm>
              <a:off x="1396800" y="3995640"/>
              <a:ext cx="72720" cy="540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12"/>
            <p:cNvSpPr/>
            <p:nvPr/>
          </p:nvSpPr>
          <p:spPr>
            <a:xfrm>
              <a:off x="1368360" y="4411800"/>
              <a:ext cx="128520" cy="0"/>
            </a:xfrm>
            <a:prstGeom prst="line">
              <a:avLst/>
            </a:prstGeom>
            <a:ln w="9360">
              <a:solidFill>
                <a:srgbClr val="4a7ebb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6" name="TextBox 25"/>
          <p:cNvSpPr/>
          <p:nvPr/>
        </p:nvSpPr>
        <p:spPr>
          <a:xfrm>
            <a:off x="616680" y="59832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6"/>
          <p:cNvSpPr/>
          <p:nvPr/>
        </p:nvSpPr>
        <p:spPr>
          <a:xfrm>
            <a:off x="623160" y="350352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6-21T22:55:33Z</dcterms:created>
  <dc:creator>Paula Rodrigues Oblessuc</dc:creator>
  <dc:description/>
  <dc:language>en-US</dc:language>
  <cp:lastModifiedBy>JOLANO</cp:lastModifiedBy>
  <dcterms:modified xsi:type="dcterms:W3CDTF">2020-01-02T15:51:25Z</dcterms:modified>
  <cp:revision>97</cp:revision>
  <dc:subject/>
  <dc:title>PowerPoint Presentation</dc:title>
</cp:coreProperties>
</file>